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264275" cy="8423275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2514" y="96"/>
      </p:cViewPr>
      <p:guideLst>
        <p:guide orient="horz" pos="2653"/>
        <p:guide pos="19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003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075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1157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8631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669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2745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6344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368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6126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1809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832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464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kumimoji="1"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kumimoji="1"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235974" y="140110"/>
            <a:ext cx="5799986" cy="8540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upplementary Figure </a:t>
            </a:r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4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he plots for the proxy SNPs around the SNPs selected by </a:t>
            </a:r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TMGP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P-values in a previous meta-analysis¹ and  r</a:t>
            </a:r>
            <a:r>
              <a:rPr lang="en-US" altLang="ja-JP" sz="11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2</a:t>
            </a: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values with the SNPs selected by STMGP) 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0031" y="1272208"/>
            <a:ext cx="5754244" cy="5054670"/>
          </a:xfrm>
          <a:prstGeom prst="rect">
            <a:avLst/>
          </a:prstGeom>
        </p:spPr>
      </p:pic>
      <p:sp>
        <p:nvSpPr>
          <p:cNvPr id="3" name="正方形/長方形 2"/>
          <p:cNvSpPr/>
          <p:nvPr/>
        </p:nvSpPr>
        <p:spPr>
          <a:xfrm rot="16200000">
            <a:off x="-2174368" y="2757916"/>
            <a:ext cx="482068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he r</a:t>
            </a:r>
            <a:r>
              <a:rPr lang="en-US" altLang="ja-JP" sz="1100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2</a:t>
            </a: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values with the SNPs selected by STMGP</a:t>
            </a:r>
            <a:endParaRPr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1415961" y="6326878"/>
            <a:ext cx="3505378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he P-values (-log10)  in a previous meta-analysis¹</a:t>
            </a:r>
            <a:endParaRPr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117987" y="7598809"/>
            <a:ext cx="6035960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. Howard DM, Adams MJ, Clarke TK, Hafferty JD, Gibson J, Shirali M, et al. Genome-wide </a:t>
            </a:r>
          </a:p>
          <a:p>
            <a:r>
              <a:rPr lang="en-US" altLang="ja-JP" sz="110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eta-analysis of depression identifies 102 independent variants and highlights the importance </a:t>
            </a:r>
          </a:p>
          <a:p>
            <a:r>
              <a:rPr lang="en-US" altLang="ja-JP" sz="110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of the prefrontal brain regions. Nature neuroscience 2019; 22(3): 343-352.1.</a:t>
            </a:r>
            <a:endParaRPr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17987" y="7299170"/>
            <a:ext cx="83548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eference</a:t>
            </a:r>
            <a:endParaRPr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13591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2</TotalTime>
  <Words>99</Words>
  <Application>Microsoft Office PowerPoint</Application>
  <PresentationFormat>ユーザー設定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hashi yuta</dc:creator>
  <cp:lastModifiedBy>takahashi yuta</cp:lastModifiedBy>
  <cp:revision>11</cp:revision>
  <dcterms:created xsi:type="dcterms:W3CDTF">2019-06-03T06:47:50Z</dcterms:created>
  <dcterms:modified xsi:type="dcterms:W3CDTF">2020-08-06T03:51:35Z</dcterms:modified>
</cp:coreProperties>
</file>